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D$8:$CD$10</c:f>
                <c:numCache>
                  <c:formatCode>General</c:formatCode>
                  <c:ptCount val="3"/>
                  <c:pt idx="0">
                    <c:v>0.58951062372439078</c:v>
                  </c:pt>
                  <c:pt idx="1">
                    <c:v>0.29362604766029748</c:v>
                  </c:pt>
                  <c:pt idx="2">
                    <c:v>0.32624277466585916</c:v>
                  </c:pt>
                </c:numCache>
              </c:numRef>
            </c:plus>
            <c:minus>
              <c:numRef>
                <c:f>Sheet1!$CD$8:$CD$10</c:f>
                <c:numCache>
                  <c:formatCode>General</c:formatCode>
                  <c:ptCount val="3"/>
                  <c:pt idx="0">
                    <c:v>0.58951062372439078</c:v>
                  </c:pt>
                  <c:pt idx="1">
                    <c:v>0.29362604766029748</c:v>
                  </c:pt>
                  <c:pt idx="2">
                    <c:v>0.326242774665859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Z$8:$BZ$10</c:f>
              <c:numCache>
                <c:formatCode>General</c:formatCode>
                <c:ptCount val="3"/>
                <c:pt idx="0">
                  <c:v>3.5011198212846133</c:v>
                </c:pt>
                <c:pt idx="1">
                  <c:v>2.1132631422770989</c:v>
                </c:pt>
                <c:pt idx="2">
                  <c:v>1.8725909214656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25-4DC2-AD15-C00011F9AF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189531264"/>
        <c:axId val="1189527904"/>
      </c:barChart>
      <c:catAx>
        <c:axId val="11895312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89527904"/>
        <c:crosses val="autoZero"/>
        <c:auto val="1"/>
        <c:lblAlgn val="ctr"/>
        <c:lblOffset val="100"/>
        <c:noMultiLvlLbl val="0"/>
      </c:catAx>
      <c:valAx>
        <c:axId val="1189527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8953126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01F6A-3D3D-889C-58E2-3B9758F539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EF5A77-DA69-127F-6CBC-8B917EBCDB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B66541-9CE1-70CA-6665-DB3E9B838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FFDE6D-5B2D-0AE7-A253-DAD4199D9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838D7D-7D55-F4BB-5C03-F8F33ADA6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0616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58EC5-20AC-CB9D-DBBE-496FB7EF5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0923C7-6EDC-FB37-94D2-754E97DA03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BDD0F9-68A8-319E-6F99-FBF2D3545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6E556-D93F-88F0-A0D2-BE29B3D06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16DC80-64BC-EF6D-B314-D9C707F1B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516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77D34A-6396-DEC0-7DC8-98D30A72F5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330E89-1DFE-BB44-6567-00CA4B7D26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D08C2D-C93B-C9E2-718A-C9B295C07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8B36B1-AF7D-53C3-2E79-CDE039D3BE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8DE5E-21AA-8E0C-C26B-969DFE3FD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1101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A4125-D60A-014E-DE32-79B61C4E1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4792E0-800E-A11E-47AA-85554A8BD8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F6AB94-1168-FD1F-FAFB-5C5E9F199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2A7C3-0B66-656C-14EE-92305B7B1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9A2A27-2210-3904-1E09-5473295C2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3966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4AD22A-D6F4-B859-FE26-9EB7E8DA9E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754E77-6AE6-0E0C-6D72-3C2BC7BF8A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3BEBBC-5781-BFB7-6C25-960B1A29B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E92DEC-61F6-DCDA-42C4-6C0279ECA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3CE0A0-A8EF-C5D9-E87C-70298430A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8566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FE1965-68C3-2A01-806B-34C2616146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F8DF6D-8746-67C4-3929-7DD243A4CD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D596CC-7E19-8B04-F9FB-718D7AC517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72A40F-C582-70DD-70D6-BBA4A049C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6709BE-6368-77CC-D6F1-B5F1D1373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3BFD2D-9A83-0A57-CE8A-22A0D6FB4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3786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B176F-F2DC-B882-B988-14B176662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84E9C0-0258-610C-7E68-950F52A292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16BFD7-7FA5-2055-8860-F894DB08DB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6CDA47-F2A0-F21D-E9CE-5FC5A62552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7576D1-B03B-6ABB-7C1B-FD70926493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3E1D34-1390-9C9B-C2B3-D301681FB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31D1423-EC82-2832-29B4-D0AB9A1BC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FFF63E-0A51-25A8-B360-2BD7F8E39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759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3233DE-786C-73AE-D250-37D8675F4C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1FD650-AF64-012E-D346-6B2D166E8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E9ECDF-6A3D-940B-852C-A44449C13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93FE53-9B85-B22E-C467-493FF8B8F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8119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DE3AC-75FF-9AE6-79F1-EA628F911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9875E9-85D8-0BA4-B293-BC747AE9E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0015C5-3D6E-00DC-860D-B3CDFA227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726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E4996A-2F7C-A40F-A724-1EEEFEBE9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B6ECD1-D971-045A-C89D-161474A440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D091C0-8529-97D6-62AA-E3157D0BA3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BD25B1-B0A8-E97A-18C5-CC9945216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A59648-2E75-B29D-C242-7CFB57B9D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62E1EB-629C-648E-B53D-D86C12EC9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330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00F38-58B9-F061-32CA-2372625DF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40AFCD-EA42-AFEF-E885-A7B940860A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157208-6EF0-5CBB-D563-831B5DA3E1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79CE93-A477-A536-A6BE-02E5B4C38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5E5C35-EF10-8A57-11EE-6C305CDA1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CE02E9-25F4-65FE-74AA-89AC34E2E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1808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DC3082-5FE3-4A11-E65B-EFD2CEC83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D31F7B-8D86-1617-04C9-9206A71879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B5692F-2F2A-52DF-A7DE-60FBBF243D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077FD-E5F3-40AA-B63D-7F9F2A70E060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C1F35-74BD-DE98-71AC-DC1DD80838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259D30-8CB4-8EEF-EFE2-9139DAE62F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454BC-18B1-4466-8FC6-41C05DB7FC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5616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chart" Target="../charts/chart1.xml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C0B77A3E-869E-1D4E-5A0D-528111C8E784}"/>
              </a:ext>
            </a:extLst>
          </p:cNvPr>
          <p:cNvSpPr txBox="1"/>
          <p:nvPr/>
        </p:nvSpPr>
        <p:spPr>
          <a:xfrm>
            <a:off x="6260243" y="1329615"/>
            <a:ext cx="158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 Nova" panose="020B0504020202020204" pitchFamily="34" charset="0"/>
              </a:rPr>
              <a:t>B</a:t>
            </a:r>
          </a:p>
        </p:txBody>
      </p:sp>
      <p:grpSp>
        <p:nvGrpSpPr>
          <p:cNvPr id="89" name="Group 88">
            <a:extLst>
              <a:ext uri="{FF2B5EF4-FFF2-40B4-BE49-F238E27FC236}">
                <a16:creationId xmlns:a16="http://schemas.microsoft.com/office/drawing/2014/main" id="{6523AD92-9304-7454-2231-5180A490370D}"/>
              </a:ext>
            </a:extLst>
          </p:cNvPr>
          <p:cNvGrpSpPr/>
          <p:nvPr/>
        </p:nvGrpSpPr>
        <p:grpSpPr>
          <a:xfrm>
            <a:off x="2024604" y="971420"/>
            <a:ext cx="4129897" cy="3925081"/>
            <a:chOff x="206653" y="512388"/>
            <a:chExt cx="4129897" cy="3925081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AD893DE7-48AE-C6B6-E209-231C8739ED6D}"/>
                </a:ext>
              </a:extLst>
            </p:cNvPr>
            <p:cNvGrpSpPr/>
            <p:nvPr/>
          </p:nvGrpSpPr>
          <p:grpSpPr>
            <a:xfrm>
              <a:off x="517810" y="689761"/>
              <a:ext cx="3818740" cy="3452359"/>
              <a:chOff x="1421563" y="517235"/>
              <a:chExt cx="3818740" cy="345235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D9FAF44F-AB99-F6F8-ECAE-D37C53489A5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421563" y="517235"/>
                <a:ext cx="1215668" cy="1235366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FA20642-7B0C-176C-8A4C-785DBD55FD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83128" y="517235"/>
                <a:ext cx="1250932" cy="1235366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B1BAA79-6AEE-868A-871D-714410C0EE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85126" y="517235"/>
                <a:ext cx="1255177" cy="1235366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178CAE72-C895-0F09-CF04-7DBFCECC2B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rot="5400000">
                <a:off x="1540788" y="1694665"/>
                <a:ext cx="977220" cy="1215667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3392652E-B405-7565-64C4-7492481AA3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5400000">
                <a:off x="2819983" y="1677035"/>
                <a:ext cx="977222" cy="1250932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20647B41-8030-F8B4-6132-50CFAE7CCC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 rot="5400000">
                <a:off x="4121981" y="1677033"/>
                <a:ext cx="977221" cy="1250932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28962D87-B57E-7737-11CA-74AF376904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421563" y="2835207"/>
                <a:ext cx="1210863" cy="1134387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88D089C1-7143-FCED-C292-B8C6312D18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683128" y="2835207"/>
                <a:ext cx="1250932" cy="1134387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AC3E7382-0E5E-64DC-FE2A-F35C361A3A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985125" y="2835207"/>
                <a:ext cx="1252883" cy="1134387"/>
              </a:xfrm>
              <a:prstGeom prst="rect">
                <a:avLst/>
              </a:prstGeom>
            </p:spPr>
          </p:pic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BB3A908-B872-3A19-788E-54365B6CF353}"/>
                </a:ext>
              </a:extLst>
            </p:cNvPr>
            <p:cNvSpPr txBox="1"/>
            <p:nvPr/>
          </p:nvSpPr>
          <p:spPr>
            <a:xfrm>
              <a:off x="904022" y="4129692"/>
              <a:ext cx="6572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Ran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0B9EA6DB-1A98-C3DF-DC29-A451E65E2DC3}"/>
                </a:ext>
              </a:extLst>
            </p:cNvPr>
            <p:cNvSpPr txBox="1"/>
            <p:nvPr/>
          </p:nvSpPr>
          <p:spPr>
            <a:xfrm>
              <a:off x="2142621" y="4129692"/>
              <a:ext cx="5813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DAPI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F775427-E332-B4D7-8FDE-5A452BEAC64A}"/>
                </a:ext>
              </a:extLst>
            </p:cNvPr>
            <p:cNvSpPr txBox="1"/>
            <p:nvPr/>
          </p:nvSpPr>
          <p:spPr>
            <a:xfrm>
              <a:off x="3394829" y="4129692"/>
              <a:ext cx="6942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Merge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C314DFA-369E-5CD9-453C-77774FEC2D8B}"/>
                </a:ext>
              </a:extLst>
            </p:cNvPr>
            <p:cNvSpPr txBox="1"/>
            <p:nvPr/>
          </p:nvSpPr>
          <p:spPr>
            <a:xfrm rot="16200000">
              <a:off x="-257141" y="2160168"/>
              <a:ext cx="12353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siPlxnB1-1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003728A-5B5A-12FC-50DB-ECB12D5FDDFD}"/>
                </a:ext>
              </a:extLst>
            </p:cNvPr>
            <p:cNvSpPr txBox="1"/>
            <p:nvPr/>
          </p:nvSpPr>
          <p:spPr>
            <a:xfrm rot="16200000">
              <a:off x="-196557" y="3381178"/>
              <a:ext cx="11141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siPlxnB1-2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D0F5E56-7B02-AED9-2A5A-2D0A94B41E1D}"/>
                </a:ext>
              </a:extLst>
            </p:cNvPr>
            <p:cNvSpPr txBox="1"/>
            <p:nvPr/>
          </p:nvSpPr>
          <p:spPr>
            <a:xfrm rot="16200000">
              <a:off x="-196557" y="915598"/>
              <a:ext cx="11141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err="1">
                  <a:latin typeface="Arial Nova" panose="020B0504020202020204" pitchFamily="34" charset="0"/>
                </a:rPr>
                <a:t>siControl</a:t>
              </a:r>
              <a:endParaRPr lang="en-GB" sz="1400" dirty="0">
                <a:latin typeface="Arial Nova" panose="020B0504020202020204" pitchFamily="34" charset="0"/>
              </a:endParaRPr>
            </a:p>
          </p:txBody>
        </p: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833EB603-E4FB-2093-D8EA-FB3729CC9E27}"/>
              </a:ext>
            </a:extLst>
          </p:cNvPr>
          <p:cNvGrpSpPr/>
          <p:nvPr/>
        </p:nvGrpSpPr>
        <p:grpSpPr>
          <a:xfrm>
            <a:off x="6260244" y="1329615"/>
            <a:ext cx="1528726" cy="2715772"/>
            <a:chOff x="5351045" y="-435754"/>
            <a:chExt cx="1528726" cy="2715772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4135172-4252-69AB-32AB-FB46F756E96B}"/>
                </a:ext>
              </a:extLst>
            </p:cNvPr>
            <p:cNvSpPr txBox="1"/>
            <p:nvPr/>
          </p:nvSpPr>
          <p:spPr>
            <a:xfrm>
              <a:off x="6453387" y="701246"/>
              <a:ext cx="2584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*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F127085-9DF9-C410-26BA-26AE8799EC1F}"/>
                </a:ext>
              </a:extLst>
            </p:cNvPr>
            <p:cNvSpPr txBox="1"/>
            <p:nvPr/>
          </p:nvSpPr>
          <p:spPr>
            <a:xfrm>
              <a:off x="6159464" y="640967"/>
              <a:ext cx="2584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*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976904AD-B077-0725-B790-381C2E6D5369}"/>
                </a:ext>
              </a:extLst>
            </p:cNvPr>
            <p:cNvGrpSpPr/>
            <p:nvPr/>
          </p:nvGrpSpPr>
          <p:grpSpPr>
            <a:xfrm>
              <a:off x="5351045" y="-435754"/>
              <a:ext cx="1528726" cy="2715772"/>
              <a:chOff x="5351045" y="-435754"/>
              <a:chExt cx="1528726" cy="2715772"/>
            </a:xfrm>
          </p:grpSpPr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957B6B94-8F5A-9BC1-CAD4-6FF8FC4E7007}"/>
                  </a:ext>
                </a:extLst>
              </p:cNvPr>
              <p:cNvGrpSpPr/>
              <p:nvPr/>
            </p:nvGrpSpPr>
            <p:grpSpPr>
              <a:xfrm>
                <a:off x="5351045" y="-435754"/>
                <a:ext cx="1343822" cy="2715772"/>
                <a:chOff x="1870837" y="3120555"/>
                <a:chExt cx="1343822" cy="2715772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0521FD19-7D04-6658-FB69-BC888775E0A6}"/>
                    </a:ext>
                  </a:extLst>
                </p:cNvPr>
                <p:cNvSpPr txBox="1"/>
                <p:nvPr/>
              </p:nvSpPr>
              <p:spPr>
                <a:xfrm rot="16200000">
                  <a:off x="898426" y="4092966"/>
                  <a:ext cx="22218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Nuclear/cytoplasmic ratio</a:t>
                  </a:r>
                </a:p>
              </p:txBody>
            </p:sp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376D12B6-978B-77D6-B427-34B02107A6A3}"/>
                    </a:ext>
                  </a:extLst>
                </p:cNvPr>
                <p:cNvGrpSpPr/>
                <p:nvPr/>
              </p:nvGrpSpPr>
              <p:grpSpPr>
                <a:xfrm>
                  <a:off x="2323037" y="4933387"/>
                  <a:ext cx="891622" cy="902940"/>
                  <a:chOff x="2323037" y="4913381"/>
                  <a:chExt cx="891622" cy="902940"/>
                </a:xfrm>
              </p:grpSpPr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AF06429E-A849-AFA6-7865-750C89DDD03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317378" y="5226351"/>
                    <a:ext cx="90293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>
                        <a:latin typeface="Arial Nova" panose="020B0504020202020204" pitchFamily="34" charset="0"/>
                      </a:rPr>
                      <a:t>siPlxnB1-1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72A0C1A2-DCE0-8D63-5EDC-D229EB8BF4C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624690" y="5226352"/>
                    <a:ext cx="90293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>
                        <a:latin typeface="Arial Nova" panose="020B0504020202020204" pitchFamily="34" charset="0"/>
                      </a:rPr>
                      <a:t>siPlxnB1-2</a:t>
                    </a: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2C471614-A881-2E6F-AD5D-F5EF20AE5EB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066172" y="5183872"/>
                    <a:ext cx="790729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dirty="0" err="1">
                        <a:latin typeface="Arial Nova" panose="020B0504020202020204" pitchFamily="34" charset="0"/>
                      </a:rPr>
                      <a:t>siControl</a:t>
                    </a:r>
                    <a:endParaRPr lang="en-GB" sz="1200" dirty="0">
                      <a:latin typeface="Arial Nova" panose="020B0504020202020204" pitchFamily="34" charset="0"/>
                    </a:endParaRPr>
                  </a:p>
                </p:txBody>
              </p:sp>
            </p:grpSp>
          </p:grpSp>
          <p:graphicFrame>
            <p:nvGraphicFramePr>
              <p:cNvPr id="84" name="Chart 83">
                <a:extLst>
                  <a:ext uri="{FF2B5EF4-FFF2-40B4-BE49-F238E27FC236}">
                    <a16:creationId xmlns:a16="http://schemas.microsoft.com/office/drawing/2014/main" id="{5CFE2C84-FE0A-6F7D-0D21-45B585293884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5582259" y="100304"/>
              <a:ext cx="1297512" cy="149259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</p:grpSp>
      </p:grpSp>
      <p:sp>
        <p:nvSpPr>
          <p:cNvPr id="87" name="TextBox 86">
            <a:extLst>
              <a:ext uri="{FF2B5EF4-FFF2-40B4-BE49-F238E27FC236}">
                <a16:creationId xmlns:a16="http://schemas.microsoft.com/office/drawing/2014/main" id="{4FFE0ACF-AC43-6BC1-F894-E542427C3C69}"/>
              </a:ext>
            </a:extLst>
          </p:cNvPr>
          <p:cNvSpPr txBox="1"/>
          <p:nvPr/>
        </p:nvSpPr>
        <p:spPr>
          <a:xfrm>
            <a:off x="1952625" y="748757"/>
            <a:ext cx="7595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 Nova" panose="020B0504020202020204" pitchFamily="34" charset="0"/>
              </a:rPr>
              <a:t>A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48868715-BF05-14FE-0642-0A16E62010F0}"/>
              </a:ext>
            </a:extLst>
          </p:cNvPr>
          <p:cNvCxnSpPr/>
          <p:nvPr/>
        </p:nvCxnSpPr>
        <p:spPr>
          <a:xfrm>
            <a:off x="2421399" y="4455108"/>
            <a:ext cx="16948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7D9591BC-EAC9-5092-E4F8-1498581C9D3B}"/>
              </a:ext>
            </a:extLst>
          </p:cNvPr>
          <p:cNvSpPr txBox="1"/>
          <p:nvPr/>
        </p:nvSpPr>
        <p:spPr>
          <a:xfrm>
            <a:off x="276515" y="4971309"/>
            <a:ext cx="11638969" cy="12512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GB" sz="1200" b="1" kern="12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6. Depletion of PlexinB1 promotes the translocation of Ran to the cytoplasm  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ssociated with figure 3)</a:t>
            </a: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C3 cells transfected with non-silencing siRNA or siRNA to PlexinB1, stained for endogenous Ran (representative images) scale bar=10</a:t>
            </a:r>
            <a:r>
              <a:rPr lang="en-GB" sz="1200" kern="12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, 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ar chart showing ratio of nuclear/cytoplasmic Ran staining, (n=3) (*p=&lt;0.05,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udent T-Test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0955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1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ova</vt:lpstr>
      <vt:lpstr>Calibri</vt:lpstr>
      <vt:lpstr>Calibri Light</vt:lpstr>
      <vt:lpstr>Symbol</vt:lpstr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2</cp:revision>
  <dcterms:created xsi:type="dcterms:W3CDTF">2023-06-02T16:42:51Z</dcterms:created>
  <dcterms:modified xsi:type="dcterms:W3CDTF">2023-06-02T17:17:11Z</dcterms:modified>
</cp:coreProperties>
</file>